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5" d="100"/>
          <a:sy n="125" d="100"/>
        </p:scale>
        <p:origin x="5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5DEBC-7C82-4142-8F73-EFCCDCA3F7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7C5867B-71BD-2A47-B6F3-77E19007FC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951E64-F1A3-324A-A4FB-897DE8466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BC994-3EE6-7049-921E-4352CCB6A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EE266B-19DB-C34A-8874-546AF32F1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545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84ECD-D572-464B-B241-107F6091BC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CC7D54-E371-E347-AF83-76C4054FF9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236B6-0F7E-754A-881F-B6F0F277F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4385FD-5076-4A47-B885-F59401DAF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2D087-76F6-4C47-AE0F-9F1CE27F1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572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02236C-3A11-7440-95BC-B9D359024B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B037CE-4B73-7E48-A3DC-234464E438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C45572-25D1-8047-A3BF-25C79D867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3331CB-7A5F-6F40-9911-752F05277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D73167-82D2-404B-87D7-5190F5229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050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F5907A-C77E-CC46-BB99-DF7089ADA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DC5C3E-F1EF-1441-AAF3-17A861D73E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0A081F-49E3-294D-A530-820D94612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AAB392-CD2E-3947-B6B8-2CB910E68A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9212F5-3954-984C-80BB-1045B63D3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265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1B9CA-9CA4-6543-877C-165BCC033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4E29DA-2DB5-B141-85F5-D205946453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D70D47-A3E4-264E-A488-BCBBA4DDD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A780A6-8511-2741-9BB4-ADC0F7E5D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7CA461-BD2E-A44E-921D-81384496A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260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C4B4B8-1BB2-B448-B8A6-F24286A642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E1B609-7FFE-6740-804F-CFF73E8B8C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8E1EAE-F8FD-AF4F-92FA-3EC7AC436C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FF7ED9-0B42-5845-A503-448D6B1E9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2B3349-D042-E446-8B2B-D2C1AB158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2B18DC-4A24-2C48-AFB9-B28E4B0FC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020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E8A3C-8F17-1642-9D9D-F45AB6A7B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3B3AE7-DEA6-B649-8C9C-2383C99FB3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129EE5-A180-9F49-9B50-BDD858638F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5419DE-C85F-9C47-B42D-0784271EFF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E4C4F8-9F06-7D46-AE28-055F047369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52D55A-74F7-FD4A-9FF0-077C2B2D7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EB60F32-A9A6-8D40-8EF5-0FFC480BE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014E3-9A42-4D47-ADC5-6B4B01276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323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BAD29-3F39-B44B-ABD5-0B0CF71FB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BAA520-DC25-1145-AF37-13ECC9048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45CB07-0D2B-B046-BB79-678A92105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805D76-65F4-1845-978C-1DBF707E8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083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DF6C4C-E387-0348-95A3-9AAC93472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BE3750-A085-564D-A610-C6568668D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E5DB4EF-6F3F-7149-818D-2DEE0E919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762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332D8-6D81-AD41-916F-9A1141B30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5AFDD-1CAA-8740-86AC-93FFDF330D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AECCF4-709C-0044-8DE6-6B35CE5D4E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C03345-6F0B-5245-8E54-0202C2871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FD43A-21FA-6E4E-BC0E-ED3710E01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8532E4-D534-1E4B-AA8F-5B5CA115F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877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3AC7D8-FE12-D54E-9526-5B1B4C311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F39671-AB91-8D41-AD5C-DF223C08C5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98CE23-092E-5945-BDA6-67254BD37F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6F59D2-F674-DB49-8407-EC5E20318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B0352C-6097-0E4A-87F3-3789D525B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97719D-58C7-E84B-9B67-3C923C585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309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BD7145-6B2E-8C40-9BB3-916109D277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3212B5-BC7E-7E45-876C-4EF4C6AD35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8C40B-CE6D-9146-B497-91685A9EFD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613DC-A555-DF4C-B134-FB581D160C23}" type="datetimeFigureOut">
              <a:rPr lang="en-US" smtClean="0"/>
              <a:t>6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16FB8-60A2-8F4F-89E3-1BA67F8D4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8B418B-F454-6342-935F-58D3A315EC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6A9A1-F7DB-B140-95A6-FE17B1CA9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072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8EB0902-9A1B-8247-93B8-9356A98723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3600" y="2577222"/>
            <a:ext cx="7367270" cy="379690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D2156DA-A531-5C4F-B8F7-38D49149D1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480" y="765572"/>
            <a:ext cx="3444764" cy="32232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CD897F3-1A0E-2F4C-84E3-798909D033FB}"/>
              </a:ext>
            </a:extLst>
          </p:cNvPr>
          <p:cNvSpPr txBox="1"/>
          <p:nvPr/>
        </p:nvSpPr>
        <p:spPr>
          <a:xfrm>
            <a:off x="1153632" y="370039"/>
            <a:ext cx="2126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hole bone marrow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56AF9F-760C-474D-B0F0-E4461F472E6E}"/>
              </a:ext>
            </a:extLst>
          </p:cNvPr>
          <p:cNvSpPr txBox="1"/>
          <p:nvPr/>
        </p:nvSpPr>
        <p:spPr>
          <a:xfrm>
            <a:off x="5888192" y="2192536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 (-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FFED5C-CEDE-EA4E-9056-882F511D6008}"/>
              </a:ext>
            </a:extLst>
          </p:cNvPr>
          <p:cNvSpPr txBox="1"/>
          <p:nvPr/>
        </p:nvSpPr>
        <p:spPr>
          <a:xfrm>
            <a:off x="10135072" y="222618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 (+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E2382F-B6F8-F64D-93B2-69C1392B53B0}"/>
              </a:ext>
            </a:extLst>
          </p:cNvPr>
          <p:cNvSpPr txBox="1"/>
          <p:nvPr/>
        </p:nvSpPr>
        <p:spPr>
          <a:xfrm>
            <a:off x="7274560" y="1513840"/>
            <a:ext cx="2002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1+ CD117+ Cell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24EEBB-90BE-0C44-8D43-0F3309E529A2}"/>
              </a:ext>
            </a:extLst>
          </p:cNvPr>
          <p:cNvSpPr txBox="1"/>
          <p:nvPr/>
        </p:nvSpPr>
        <p:spPr>
          <a:xfrm>
            <a:off x="4673600" y="231539"/>
            <a:ext cx="20425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Wild-type Mouse </a:t>
            </a:r>
          </a:p>
        </p:txBody>
      </p:sp>
    </p:spTree>
    <p:extLst>
      <p:ext uri="{BB962C8B-B14F-4D97-AF65-F5344CB8AC3E}">
        <p14:creationId xmlns:p14="http://schemas.microsoft.com/office/powerpoint/2010/main" val="2001515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CD897F3-1A0E-2F4C-84E3-798909D033FB}"/>
              </a:ext>
            </a:extLst>
          </p:cNvPr>
          <p:cNvSpPr txBox="1"/>
          <p:nvPr/>
        </p:nvSpPr>
        <p:spPr>
          <a:xfrm>
            <a:off x="1153632" y="370039"/>
            <a:ext cx="2126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hole bone marrow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56AF9F-760C-474D-B0F0-E4461F472E6E}"/>
              </a:ext>
            </a:extLst>
          </p:cNvPr>
          <p:cNvSpPr txBox="1"/>
          <p:nvPr/>
        </p:nvSpPr>
        <p:spPr>
          <a:xfrm>
            <a:off x="5888192" y="2192536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 (-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FFED5C-CEDE-EA4E-9056-882F511D6008}"/>
              </a:ext>
            </a:extLst>
          </p:cNvPr>
          <p:cNvSpPr txBox="1"/>
          <p:nvPr/>
        </p:nvSpPr>
        <p:spPr>
          <a:xfrm>
            <a:off x="10135072" y="222618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 (+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E2382F-B6F8-F64D-93B2-69C1392B53B0}"/>
              </a:ext>
            </a:extLst>
          </p:cNvPr>
          <p:cNvSpPr txBox="1"/>
          <p:nvPr/>
        </p:nvSpPr>
        <p:spPr>
          <a:xfrm>
            <a:off x="7274560" y="1513840"/>
            <a:ext cx="2002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1+ CD117+ Cell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24EEBB-90BE-0C44-8D43-0F3309E529A2}"/>
              </a:ext>
            </a:extLst>
          </p:cNvPr>
          <p:cNvSpPr txBox="1"/>
          <p:nvPr/>
        </p:nvSpPr>
        <p:spPr>
          <a:xfrm>
            <a:off x="4673600" y="231539"/>
            <a:ext cx="23139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1 </a:t>
            </a:r>
            <a:r>
              <a:rPr lang="en-US" sz="2000" dirty="0" err="1"/>
              <a:t>tetO</a:t>
            </a:r>
            <a:r>
              <a:rPr lang="en-US" sz="2000" dirty="0"/>
              <a:t>-HAC Mouse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7D68981-9967-7949-8C35-104A015CB0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530" y="739371"/>
            <a:ext cx="3288030" cy="312254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1899FAB-7CF0-F54E-939F-0EF1F5C488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3100" y="2718778"/>
            <a:ext cx="6905800" cy="3519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36475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CD897F3-1A0E-2F4C-84E3-798909D033FB}"/>
              </a:ext>
            </a:extLst>
          </p:cNvPr>
          <p:cNvSpPr txBox="1"/>
          <p:nvPr/>
        </p:nvSpPr>
        <p:spPr>
          <a:xfrm>
            <a:off x="1153632" y="370039"/>
            <a:ext cx="2126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hole bone marrow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56AF9F-760C-474D-B0F0-E4461F472E6E}"/>
              </a:ext>
            </a:extLst>
          </p:cNvPr>
          <p:cNvSpPr txBox="1"/>
          <p:nvPr/>
        </p:nvSpPr>
        <p:spPr>
          <a:xfrm>
            <a:off x="5888192" y="2192536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 (-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FFED5C-CEDE-EA4E-9056-882F511D6008}"/>
              </a:ext>
            </a:extLst>
          </p:cNvPr>
          <p:cNvSpPr txBox="1"/>
          <p:nvPr/>
        </p:nvSpPr>
        <p:spPr>
          <a:xfrm>
            <a:off x="10135072" y="222618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 (+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E2382F-B6F8-F64D-93B2-69C1392B53B0}"/>
              </a:ext>
            </a:extLst>
          </p:cNvPr>
          <p:cNvSpPr txBox="1"/>
          <p:nvPr/>
        </p:nvSpPr>
        <p:spPr>
          <a:xfrm>
            <a:off x="7274560" y="1513840"/>
            <a:ext cx="2002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a1+ CD117+ Cell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24EEBB-90BE-0C44-8D43-0F3309E529A2}"/>
              </a:ext>
            </a:extLst>
          </p:cNvPr>
          <p:cNvSpPr txBox="1"/>
          <p:nvPr/>
        </p:nvSpPr>
        <p:spPr>
          <a:xfrm>
            <a:off x="4673600" y="231539"/>
            <a:ext cx="23139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1 </a:t>
            </a:r>
            <a:r>
              <a:rPr lang="en-US" sz="2000" dirty="0" err="1"/>
              <a:t>tetO</a:t>
            </a:r>
            <a:r>
              <a:rPr lang="en-US" sz="2000" dirty="0"/>
              <a:t>-HAC Mouse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AB7029D-0DFE-DE4B-8ADE-CDE7752DF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030" y="814856"/>
            <a:ext cx="3082290" cy="282265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2DEB86F-0D1C-E44D-B714-66A3C735AA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1359" y="2595518"/>
            <a:ext cx="7065421" cy="36376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0127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4</Words>
  <Application>Microsoft Macintosh PowerPoint</Application>
  <PresentationFormat>Widescreen</PresentationFormat>
  <Paragraphs>1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2-06-17T20:04:48Z</dcterms:created>
  <dcterms:modified xsi:type="dcterms:W3CDTF">2022-06-17T20:11:23Z</dcterms:modified>
</cp:coreProperties>
</file>